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5" r:id="rId4"/>
    <p:sldId id="264" r:id="rId5"/>
    <p:sldId id="263" r:id="rId6"/>
    <p:sldId id="262" r:id="rId7"/>
    <p:sldId id="266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2574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1F61C-37A4-4DB3-814E-2F8D40A12810}" type="datetimeFigureOut">
              <a:rPr lang="en-GB" smtClean="0"/>
              <a:pPr/>
              <a:t>10/0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21DC8A-6D26-4897-A4F8-98321BA29939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5522" y="1331640"/>
            <a:ext cx="5353050" cy="2990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6632" y="4644008"/>
            <a:ext cx="6650831" cy="380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11" name="Table 10"/>
          <p:cNvGraphicFramePr>
            <a:graphicFrameLocks noGrp="1"/>
          </p:cNvGraphicFramePr>
          <p:nvPr/>
        </p:nvGraphicFramePr>
        <p:xfrm>
          <a:off x="2348880" y="746284"/>
          <a:ext cx="2664296" cy="253365"/>
        </p:xfrm>
        <a:graphic>
          <a:graphicData uri="http://schemas.openxmlformats.org/drawingml/2006/table">
            <a:tbl>
              <a:tblPr/>
              <a:tblGrid>
                <a:gridCol w="2664296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K)VLDQITTNPGGIGGVESLR(G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64394" y="1331640"/>
            <a:ext cx="5343525" cy="2943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14312" y="4644008"/>
            <a:ext cx="6643688" cy="28932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2492040" y="746284"/>
          <a:ext cx="2088232" cy="253365"/>
        </p:xfrm>
        <a:graphic>
          <a:graphicData uri="http://schemas.openxmlformats.org/drawingml/2006/table">
            <a:tbl>
              <a:tblPr/>
              <a:tblGrid>
                <a:gridCol w="2088232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R)SVEQTSHVVYLPNK(T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0094" y="1331640"/>
            <a:ext cx="5334000" cy="2990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28885" y="4644008"/>
            <a:ext cx="5636419" cy="30789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2338982" y="746284"/>
          <a:ext cx="2016224" cy="253365"/>
        </p:xfrm>
        <a:graphic>
          <a:graphicData uri="http://schemas.openxmlformats.org/drawingml/2006/table">
            <a:tbl>
              <a:tblPr/>
              <a:tblGrid>
                <a:gridCol w="2016224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R)ALGLLIEDPGAIITR(N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16570" y="1259632"/>
            <a:ext cx="5314950" cy="2981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48680" y="4427984"/>
            <a:ext cx="5850731" cy="39933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2033885" y="746284"/>
          <a:ext cx="2880320" cy="253365"/>
        </p:xfrm>
        <a:graphic>
          <a:graphicData uri="http://schemas.openxmlformats.org/drawingml/2006/table">
            <a:tbl>
              <a:tblPr/>
              <a:tblGrid>
                <a:gridCol w="288032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K)AAWDAGATEAEMEPILMDIR(H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92968" y="1331640"/>
            <a:ext cx="5314950" cy="2981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42887" y="4644008"/>
            <a:ext cx="6615113" cy="2686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2489993" y="746284"/>
          <a:ext cx="2120900" cy="253365"/>
        </p:xfrm>
        <a:graphic>
          <a:graphicData uri="http://schemas.openxmlformats.org/drawingml/2006/table">
            <a:tbl>
              <a:tblPr/>
              <a:tblGrid>
                <a:gridCol w="21209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K)DAMLADVQPIWDK(A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22151" y="1331640"/>
            <a:ext cx="5353050" cy="2962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3976" y="4644008"/>
            <a:ext cx="6629400" cy="2486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12" name="Table 11"/>
          <p:cNvGraphicFramePr>
            <a:graphicFrameLocks noGrp="1"/>
          </p:cNvGraphicFramePr>
          <p:nvPr/>
        </p:nvGraphicFramePr>
        <p:xfrm>
          <a:off x="2438226" y="683568"/>
          <a:ext cx="2120900" cy="253365"/>
        </p:xfrm>
        <a:graphic>
          <a:graphicData uri="http://schemas.openxmlformats.org/drawingml/2006/table">
            <a:tbl>
              <a:tblPr/>
              <a:tblGrid>
                <a:gridCol w="21209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R)GAEQIYIPVLIK(K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54807" y="1331640"/>
            <a:ext cx="5324475" cy="2933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6632" y="4644008"/>
            <a:ext cx="6600825" cy="24931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2356594" y="746284"/>
          <a:ext cx="2120900" cy="253365"/>
        </p:xfrm>
        <a:graphic>
          <a:graphicData uri="http://schemas.openxmlformats.org/drawingml/2006/table">
            <a:tbl>
              <a:tblPr/>
              <a:tblGrid>
                <a:gridCol w="21209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(R)NFLDNPLTALAK(S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</TotalTime>
  <Words>21</Words>
  <Application>Microsoft Office PowerPoint</Application>
  <PresentationFormat>On-screen Show (4:3)</PresentationFormat>
  <Paragraphs>7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lebihan</dc:creator>
  <cp:lastModifiedBy>tlebihan</cp:lastModifiedBy>
  <cp:revision>9</cp:revision>
  <dcterms:created xsi:type="dcterms:W3CDTF">2012-02-03T19:41:49Z</dcterms:created>
  <dcterms:modified xsi:type="dcterms:W3CDTF">2012-02-10T12:14:31Z</dcterms:modified>
</cp:coreProperties>
</file>